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7" d="100"/>
          <a:sy n="67" d="100"/>
        </p:scale>
        <p:origin x="644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chu\Documents\CIHI%20HCV%20data\HCV_hospitalizations_updated%20GRAPH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Yearly rate of HCV-specific</a:t>
            </a:r>
            <a:r>
              <a:rPr lang="en-US" baseline="0"/>
              <a:t> hospitalizations per 1,000,000 of Canadian population, by sex</a:t>
            </a:r>
            <a:endParaRPr lang="en-US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lineChart>
        <c:grouping val="standard"/>
        <c:varyColors val="0"/>
        <c:ser>
          <c:idx val="7"/>
          <c:order val="0"/>
          <c:tx>
            <c:strRef>
              <c:f>Sex!$H$1</c:f>
              <c:strCache>
                <c:ptCount val="1"/>
                <c:pt idx="0">
                  <c:v>Female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cat>
            <c:numRef>
              <c:f>Sex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Sex!$H$2:$H$15</c:f>
              <c:numCache>
                <c:formatCode>General</c:formatCode>
                <c:ptCount val="14"/>
                <c:pt idx="0">
                  <c:v>178.67562703121772</c:v>
                </c:pt>
                <c:pt idx="1">
                  <c:v>168.23212150952253</c:v>
                </c:pt>
                <c:pt idx="2">
                  <c:v>177.72674319469334</c:v>
                </c:pt>
                <c:pt idx="3">
                  <c:v>187.43941374609929</c:v>
                </c:pt>
                <c:pt idx="4">
                  <c:v>196.5953852482703</c:v>
                </c:pt>
                <c:pt idx="5">
                  <c:v>191.05559660140375</c:v>
                </c:pt>
                <c:pt idx="6">
                  <c:v>189.55318577891791</c:v>
                </c:pt>
                <c:pt idx="7">
                  <c:v>190.36535273664899</c:v>
                </c:pt>
                <c:pt idx="8">
                  <c:v>183.8064604218543</c:v>
                </c:pt>
                <c:pt idx="9">
                  <c:v>183.15622024927367</c:v>
                </c:pt>
                <c:pt idx="10">
                  <c:v>174.29789307321704</c:v>
                </c:pt>
                <c:pt idx="11">
                  <c:v>163.83248063669561</c:v>
                </c:pt>
                <c:pt idx="12">
                  <c:v>200.8167727828156</c:v>
                </c:pt>
                <c:pt idx="13">
                  <c:v>160.530655038545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3DF-4BF7-A79B-2E84393724E3}"/>
            </c:ext>
          </c:extLst>
        </c:ser>
        <c:ser>
          <c:idx val="8"/>
          <c:order val="1"/>
          <c:tx>
            <c:strRef>
              <c:f>Sex!$I$1</c:f>
              <c:strCache>
                <c:ptCount val="1"/>
                <c:pt idx="0">
                  <c:v>Male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cat>
            <c:numRef>
              <c:f>Sex!$A$2:$A$15</c:f>
              <c:numCache>
                <c:formatCode>General</c:formatCode>
                <c:ptCount val="14"/>
                <c:pt idx="0">
                  <c:v>2006</c:v>
                </c:pt>
                <c:pt idx="1">
                  <c:v>2007</c:v>
                </c:pt>
                <c:pt idx="2">
                  <c:v>2008</c:v>
                </c:pt>
                <c:pt idx="3">
                  <c:v>2009</c:v>
                </c:pt>
                <c:pt idx="4">
                  <c:v>2010</c:v>
                </c:pt>
                <c:pt idx="5">
                  <c:v>2011</c:v>
                </c:pt>
                <c:pt idx="6">
                  <c:v>2012</c:v>
                </c:pt>
                <c:pt idx="7">
                  <c:v>2013</c:v>
                </c:pt>
                <c:pt idx="8">
                  <c:v>2014</c:v>
                </c:pt>
                <c:pt idx="9">
                  <c:v>2015</c:v>
                </c:pt>
                <c:pt idx="10">
                  <c:v>2016</c:v>
                </c:pt>
                <c:pt idx="11">
                  <c:v>2017</c:v>
                </c:pt>
                <c:pt idx="12">
                  <c:v>2018</c:v>
                </c:pt>
                <c:pt idx="13">
                  <c:v>2019</c:v>
                </c:pt>
              </c:numCache>
            </c:numRef>
          </c:cat>
          <c:val>
            <c:numRef>
              <c:f>Sex!$I$2:$I$15</c:f>
              <c:numCache>
                <c:formatCode>General</c:formatCode>
                <c:ptCount val="14"/>
                <c:pt idx="0">
                  <c:v>316.63526225445673</c:v>
                </c:pt>
                <c:pt idx="1">
                  <c:v>319.22493682377137</c:v>
                </c:pt>
                <c:pt idx="2">
                  <c:v>317.46652245714472</c:v>
                </c:pt>
                <c:pt idx="3">
                  <c:v>337.80594647687121</c:v>
                </c:pt>
                <c:pt idx="4">
                  <c:v>344.02070819476199</c:v>
                </c:pt>
                <c:pt idx="5">
                  <c:v>351.5231218873659</c:v>
                </c:pt>
                <c:pt idx="6">
                  <c:v>341.6638097839035</c:v>
                </c:pt>
                <c:pt idx="7">
                  <c:v>369.45802191979675</c:v>
                </c:pt>
                <c:pt idx="8">
                  <c:v>349.96621770924617</c:v>
                </c:pt>
                <c:pt idx="9">
                  <c:v>347.03715126704128</c:v>
                </c:pt>
                <c:pt idx="10">
                  <c:v>318.8681536836221</c:v>
                </c:pt>
                <c:pt idx="11">
                  <c:v>294.43894163426182</c:v>
                </c:pt>
                <c:pt idx="12">
                  <c:v>323.31349445656707</c:v>
                </c:pt>
                <c:pt idx="13">
                  <c:v>275.066940181370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3DF-4BF7-A79B-2E84393724E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1877036079"/>
        <c:axId val="2051827119"/>
      </c:lineChart>
      <c:catAx>
        <c:axId val="1877036079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Year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51827119"/>
        <c:crosses val="autoZero"/>
        <c:auto val="1"/>
        <c:lblAlgn val="ctr"/>
        <c:lblOffset val="100"/>
        <c:noMultiLvlLbl val="0"/>
      </c:catAx>
      <c:valAx>
        <c:axId val="2051827119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Rate per 1,000,000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1877036079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2">
  <a:schemeClr val="accent2"/>
  <a:schemeClr val="accent4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EEE8297-4DF8-D38F-59F1-463127E0144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AE0D26-CA11-A819-F506-096138097F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0DA0DD-56C8-CC00-2B2F-125928E61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96AD64-857C-A1F3-188B-8279AA8BF6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DE8A895-A3C3-4B27-FF15-D98DBCC80B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515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ABB8BC-DD11-384F-A3F9-B95A4B4AC7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E93A45D-ADC0-FD57-C8B4-3AAA412521C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3F4C89-AE4E-31B5-5D25-44BBE6ABB5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0D09FF-0359-74D8-6D29-A724A13FC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3D564F4-8C8F-B6FD-731F-2EA90A1149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5727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6FDE8A2-E021-ED45-9A9D-70DFCC9AA2D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5BB2EA7-8B93-DF05-11EF-20694C4A94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ECB64E-AF6C-4227-0A9D-952B7A3C29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920DA9-0B48-1197-E283-92FEA3F79A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351D84D-E61F-333B-A2BD-EFDA6EF2F6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52142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186D5B-46B4-8B01-82CD-29666B468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E22E343-F7AB-8FEB-4091-3E53BB78D4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7FB63FB-0DC7-9ED5-2D7A-08A37E2CC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BEA753-EC73-E550-E4FC-9642E41128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3C930D-B276-6463-DF28-CEB3B09930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25732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2347E0-4E7C-A0FF-2034-19E46E1CEC6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5E101B-6058-55F1-7695-481C0B45A8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22CA0FB-1714-EB0F-BC68-2F8EC803FE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66E13BA-F947-0274-E48C-82B7BF5D3D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03C27F-B0AF-197F-9E10-25EEB4560D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3379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060C2F-B3E9-E64A-D008-EDE108D75D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E5CD717-F030-4F03-9C47-03E3C9FD5EA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65EB1BF-5BAD-9914-002E-21638560DD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77E97F-1D91-6141-6673-59565D9D0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347D824-F072-647E-18B8-503FA9A352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D379C90-7A5A-5A23-139C-E6BEB92AC6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6923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8D1EFA-4153-90EA-C8F5-1350D64CCB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70DDF8-C8BA-0D37-7B7B-13D8AEEC9E6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F7D9DA8-3918-38D8-D2BF-2C680978E6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9058E9F-66E3-A10A-699F-504EFED901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CEFD534-A439-E749-C0EC-41C6EF2EA25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1299654-182C-960A-A8F8-5C6915E83C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C5D5252-DABC-2E58-6515-3A1A2AC582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3475D5E-A59F-BABC-B670-0C71700A55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7400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B0161B5-D801-848B-7256-6B689DA7CA6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2E888D9-6EE1-7FE1-8F07-D581B03DC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FB1DA1D-97F6-4023-D964-B4DB4C751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7AAA70-3DBB-65F0-6B4D-7D8E3D84B8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90953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EC48B0E-4E01-6F14-F042-0A3CBAA79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098739C-EDB7-91DF-72F3-A85A143498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71771E-61A4-4D99-C240-EE8BDC7309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93563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46204B-984B-F273-33A0-BD77E95B9F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288470-126B-B5D0-FE53-D306E360743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F7825C5-AD16-45E8-A854-50A0AFAAEA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805DEE5-57EB-E08E-0D09-8F52976B1B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D844BB-893C-0291-B9C2-AF2BD6B3D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5D02A7-404B-25C3-27B7-74B7C8B96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91872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A1FD9A-7884-680B-605E-DBE719481C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23C710-D313-663D-361D-CB32A6FFB48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906DA9C-9286-F639-D4C4-E436D981A4E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E485FB6-B7C4-7449-FD5F-EDC574DDCA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DB81FF7-AF3A-7AD5-11FA-E6FBC230CB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B971D-16F0-C909-53F1-38DFE80041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445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0C0AD17-56EA-3F7B-C570-BADC3E0882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D1629B6-F30C-7F2B-F639-1975BA35D1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0EDD34-2905-E32F-551F-B0669B328B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224509-B3FE-4C87-8CA6-83533FDB796F}" type="datetimeFigureOut">
              <a:rPr lang="en-US" smtClean="0"/>
              <a:t>7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BC776D-C7D5-14F0-A1F7-B89124B32C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C8A710-8B89-0E94-E029-781E5D06045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25B232-8757-4F99-9837-3730BD638E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7334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579E7628-636F-492D-B070-B45666CCEAF5}"/>
              </a:ext>
            </a:extLst>
          </p:cNvPr>
          <p:cNvGraphicFramePr>
            <a:graphicFrameLocks/>
          </p:cNvGraphicFramePr>
          <p:nvPr/>
        </p:nvGraphicFramePr>
        <p:xfrm>
          <a:off x="1470365" y="1261291"/>
          <a:ext cx="9082305" cy="429513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C3DFA574-529A-442B-BC5D-8BB701F0DEE8}"/>
              </a:ext>
            </a:extLst>
          </p:cNvPr>
          <p:cNvCxnSpPr>
            <a:cxnSpLocks/>
          </p:cNvCxnSpPr>
          <p:nvPr/>
        </p:nvCxnSpPr>
        <p:spPr>
          <a:xfrm>
            <a:off x="8911282" y="1631091"/>
            <a:ext cx="0" cy="3076832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C3DFA574-529A-442B-BC5D-8BB701F0DEE8}"/>
              </a:ext>
            </a:extLst>
          </p:cNvPr>
          <p:cNvCxnSpPr>
            <a:cxnSpLocks/>
          </p:cNvCxnSpPr>
          <p:nvPr/>
        </p:nvCxnSpPr>
        <p:spPr>
          <a:xfrm>
            <a:off x="7142206" y="1647568"/>
            <a:ext cx="0" cy="3060355"/>
          </a:xfrm>
          <a:prstGeom prst="line">
            <a:avLst/>
          </a:prstGeom>
          <a:ln w="28575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TextBox 1">
            <a:extLst>
              <a:ext uri="{FF2B5EF4-FFF2-40B4-BE49-F238E27FC236}">
                <a16:creationId xmlns:a16="http://schemas.microsoft.com/office/drawing/2014/main" id="{ED0C0C8C-FE00-64B8-E746-A3B1BDD3D2EE}"/>
              </a:ext>
            </a:extLst>
          </p:cNvPr>
          <p:cNvSpPr txBox="1"/>
          <p:nvPr/>
        </p:nvSpPr>
        <p:spPr>
          <a:xfrm>
            <a:off x="354227" y="350108"/>
            <a:ext cx="19894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3 Figure</a:t>
            </a:r>
          </a:p>
        </p:txBody>
      </p:sp>
    </p:spTree>
    <p:extLst>
      <p:ext uri="{BB962C8B-B14F-4D97-AF65-F5344CB8AC3E}">
        <p14:creationId xmlns:p14="http://schemas.microsoft.com/office/powerpoint/2010/main" val="953861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Widescreen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Women's College Hospita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u, Cherry</dc:creator>
  <cp:lastModifiedBy>Chu, Cherry</cp:lastModifiedBy>
  <cp:revision>1</cp:revision>
  <dcterms:created xsi:type="dcterms:W3CDTF">2023-07-26T15:46:41Z</dcterms:created>
  <dcterms:modified xsi:type="dcterms:W3CDTF">2023-07-26T15:46:53Z</dcterms:modified>
</cp:coreProperties>
</file>